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png" ContentType="image/png"/>
  <Override PartName="/ppt/media/image21.jpeg" ContentType="image/jpeg"/>
  <Override PartName="/ppt/media/image23.jpeg" ContentType="image/jpeg"/>
  <Override PartName="/ppt/media/image12.png" ContentType="image/png"/>
  <Override PartName="/ppt/media/image22.png" ContentType="image/png"/>
  <Override PartName="/ppt/media/image24.jpeg" ContentType="image/jpeg"/>
  <Override PartName="/ppt/media/image28.jpeg" ContentType="image/jpeg"/>
  <Override PartName="/ppt/media/image20.png" ContentType="image/png"/>
  <Override PartName="/ppt/media/image36.jpeg" ContentType="image/jpeg"/>
  <Override PartName="/ppt/media/image18.jpeg" ContentType="image/jpeg"/>
  <Override PartName="/ppt/media/image15.png" ContentType="image/png"/>
  <Override PartName="/ppt/media/image17.png" ContentType="image/png"/>
  <Override PartName="/ppt/media/image32.jpeg" ContentType="image/jpeg"/>
  <Override PartName="/ppt/media/image16.png" ContentType="image/png"/>
  <Override PartName="/ppt/media/image14.jpeg" ContentType="image/jpeg"/>
  <Override PartName="/ppt/media/image30.png" ContentType="image/png"/>
  <Override PartName="/ppt/media/image9.png" ContentType="image/png"/>
  <Override PartName="/ppt/media/image44.jpeg" ContentType="image/jpeg"/>
  <Override PartName="/ppt/media/image11.png" ContentType="image/png"/>
  <Override PartName="/ppt/media/image40.png" ContentType="image/png"/>
  <Override PartName="/ppt/media/image41.png" ContentType="image/png"/>
  <Override PartName="/ppt/media/image31.png" ContentType="image/png"/>
  <Override PartName="/ppt/media/image43.png" ContentType="image/png"/>
  <Override PartName="/ppt/media/image6.jpeg" ContentType="image/jpeg"/>
  <Override PartName="/ppt/media/image35.jpeg" ContentType="image/jpeg"/>
  <Override PartName="/ppt/media/image1.jpeg" ContentType="image/jpeg"/>
  <Override PartName="/ppt/media/image10.png" ContentType="image/png"/>
  <Override PartName="/ppt/media/image13.png" ContentType="image/png"/>
  <Override PartName="/ppt/media/image7.png" ContentType="image/png"/>
  <Override PartName="/ppt/media/image37.png" ContentType="image/png"/>
  <Override PartName="/ppt/media/image5.jpeg" ContentType="image/jpeg"/>
  <Override PartName="/ppt/media/image8.jpeg" ContentType="image/jpeg"/>
  <Override PartName="/ppt/media/image38.png" ContentType="image/png"/>
  <Override PartName="/ppt/media/image39.jpeg" ContentType="image/jpe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19.jpeg" ContentType="image/jpeg"/>
  <Override PartName="/ppt/media/image25.png" ContentType="image/png"/>
  <Override PartName="/ppt/media/image4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68B5C-D8CB-43AB-A894-36A6A31864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55F25-8CBE-4663-9382-6114E4F607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E35685-61BD-43DE-8F03-579437A1BA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3ABB4-DB09-4944-8CCF-4FBB8C299A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75D89-89A8-451E-B09B-48CA0C07AF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E0FB43-BD38-48F9-B332-F4E576636B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583CD2-2478-460D-8CA6-38F1E0D4C9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3B928-D629-4AB0-8C45-F3A079732D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DDF16-53B6-4FD3-B4FE-88520E9334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B855B9-D85F-4012-B038-FB338EADC4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C38EE-76A2-4B18-B3B7-8AC660238C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7FA31-AD91-4367-9FDC-3FBCB077BA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7AA0C6-4ACF-4245-8169-DE4BF966A7A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jpeg"/><Relationship Id="rId7" Type="http://schemas.openxmlformats.org/officeDocument/2006/relationships/image" Target="../media/image4.png"/><Relationship Id="rId8" Type="http://schemas.openxmlformats.org/officeDocument/2006/relationships/image" Target="../media/image4.png"/><Relationship Id="rId9" Type="http://schemas.openxmlformats.org/officeDocument/2006/relationships/image" Target="../media/image6.jpeg"/><Relationship Id="rId10" Type="http://schemas.openxmlformats.org/officeDocument/2006/relationships/image" Target="../media/image7.png"/><Relationship Id="rId11" Type="http://schemas.openxmlformats.org/officeDocument/2006/relationships/image" Target="../media/image7.png"/><Relationship Id="rId12" Type="http://schemas.openxmlformats.org/officeDocument/2006/relationships/image" Target="../media/image7.png"/><Relationship Id="rId13" Type="http://schemas.openxmlformats.org/officeDocument/2006/relationships/image" Target="../media/image8.jpeg"/><Relationship Id="rId14" Type="http://schemas.openxmlformats.org/officeDocument/2006/relationships/image" Target="../media/image9.png"/><Relationship Id="rId15" Type="http://schemas.openxmlformats.org/officeDocument/2006/relationships/image" Target="../media/image9.png"/><Relationship Id="rId16" Type="http://schemas.openxmlformats.org/officeDocument/2006/relationships/image" Target="../media/image9.png"/><Relationship Id="rId17" Type="http://schemas.openxmlformats.org/officeDocument/2006/relationships/image" Target="../media/image10.png"/><Relationship Id="rId18" Type="http://schemas.openxmlformats.org/officeDocument/2006/relationships/image" Target="../media/image11.png"/><Relationship Id="rId19" Type="http://schemas.openxmlformats.org/officeDocument/2006/relationships/image" Target="../media/image12.png"/><Relationship Id="rId20" Type="http://schemas.openxmlformats.org/officeDocument/2006/relationships/image" Target="../media/image13.png"/><Relationship Id="rId2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jpeg"/><Relationship Id="rId6" Type="http://schemas.openxmlformats.org/officeDocument/2006/relationships/image" Target="../media/image19.jpeg"/><Relationship Id="rId7" Type="http://schemas.openxmlformats.org/officeDocument/2006/relationships/image" Target="../media/image20.png"/><Relationship Id="rId8" Type="http://schemas.openxmlformats.org/officeDocument/2006/relationships/image" Target="../media/image20.png"/><Relationship Id="rId9" Type="http://schemas.openxmlformats.org/officeDocument/2006/relationships/image" Target="../media/image21.jpeg"/><Relationship Id="rId10" Type="http://schemas.openxmlformats.org/officeDocument/2006/relationships/image" Target="../media/image22.png"/><Relationship Id="rId11" Type="http://schemas.openxmlformats.org/officeDocument/2006/relationships/image" Target="../media/image22.png"/><Relationship Id="rId12" Type="http://schemas.openxmlformats.org/officeDocument/2006/relationships/image" Target="../media/image22.png"/><Relationship Id="rId13" Type="http://schemas.openxmlformats.org/officeDocument/2006/relationships/image" Target="../media/image23.jpeg"/><Relationship Id="rId14" Type="http://schemas.openxmlformats.org/officeDocument/2006/relationships/image" Target="../media/image24.jpeg"/><Relationship Id="rId15" Type="http://schemas.openxmlformats.org/officeDocument/2006/relationships/image" Target="../media/image25.png"/><Relationship Id="rId16" Type="http://schemas.openxmlformats.org/officeDocument/2006/relationships/image" Target="../media/image25.png"/><Relationship Id="rId17" Type="http://schemas.openxmlformats.org/officeDocument/2006/relationships/image" Target="../media/image26.png"/><Relationship Id="rId18" Type="http://schemas.openxmlformats.org/officeDocument/2006/relationships/image" Target="../media/image27.png"/><Relationship Id="rId19" Type="http://schemas.openxmlformats.org/officeDocument/2006/relationships/image" Target="../media/image28.jpeg"/><Relationship Id="rId20" Type="http://schemas.openxmlformats.org/officeDocument/2006/relationships/image" Target="../media/image29.png"/><Relationship Id="rId2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30.png"/><Relationship Id="rId3" Type="http://schemas.openxmlformats.org/officeDocument/2006/relationships/image" Target="../media/image30.png"/><Relationship Id="rId4" Type="http://schemas.openxmlformats.org/officeDocument/2006/relationships/image" Target="../media/image30.png"/><Relationship Id="rId5" Type="http://schemas.openxmlformats.org/officeDocument/2006/relationships/image" Target="../media/image31.png"/><Relationship Id="rId6" Type="http://schemas.openxmlformats.org/officeDocument/2006/relationships/image" Target="../media/image31.png"/><Relationship Id="rId7" Type="http://schemas.openxmlformats.org/officeDocument/2006/relationships/image" Target="../media/image31.png"/><Relationship Id="rId8" Type="http://schemas.openxmlformats.org/officeDocument/2006/relationships/image" Target="../media/image31.pn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2.jpeg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jpeg"/><Relationship Id="rId5" Type="http://schemas.openxmlformats.org/officeDocument/2006/relationships/image" Target="../media/image36.jpeg"/><Relationship Id="rId6" Type="http://schemas.openxmlformats.org/officeDocument/2006/relationships/image" Target="../media/image37.png"/><Relationship Id="rId7" Type="http://schemas.openxmlformats.org/officeDocument/2006/relationships/image" Target="../media/image36.jpeg"/><Relationship Id="rId8" Type="http://schemas.openxmlformats.org/officeDocument/2006/relationships/image" Target="../media/image37.png"/><Relationship Id="rId9" Type="http://schemas.openxmlformats.org/officeDocument/2006/relationships/image" Target="../media/image38.png"/><Relationship Id="rId10" Type="http://schemas.openxmlformats.org/officeDocument/2006/relationships/image" Target="../media/image38.png"/><Relationship Id="rId11" Type="http://schemas.openxmlformats.org/officeDocument/2006/relationships/image" Target="../media/image38.png"/><Relationship Id="rId12" Type="http://schemas.openxmlformats.org/officeDocument/2006/relationships/image" Target="../media/image38.png"/><Relationship Id="rId13" Type="http://schemas.openxmlformats.org/officeDocument/2006/relationships/image" Target="../media/image39.jpeg"/><Relationship Id="rId14" Type="http://schemas.openxmlformats.org/officeDocument/2006/relationships/image" Target="../media/image40.png"/><Relationship Id="rId15" Type="http://schemas.openxmlformats.org/officeDocument/2006/relationships/image" Target="../media/image39.jpeg"/><Relationship Id="rId16" Type="http://schemas.openxmlformats.org/officeDocument/2006/relationships/image" Target="../media/image40.png"/><Relationship Id="rId17" Type="http://schemas.openxmlformats.org/officeDocument/2006/relationships/image" Target="../media/image41.png"/><Relationship Id="rId18" Type="http://schemas.openxmlformats.org/officeDocument/2006/relationships/image" Target="../media/image42.jpeg"/><Relationship Id="rId19" Type="http://schemas.openxmlformats.org/officeDocument/2006/relationships/image" Target="../media/image42.jpeg"/><Relationship Id="rId20" Type="http://schemas.openxmlformats.org/officeDocument/2006/relationships/image" Target="../media/image41.png"/><Relationship Id="rId21" Type="http://schemas.openxmlformats.org/officeDocument/2006/relationships/image" Target="../media/image43.png"/><Relationship Id="rId22" Type="http://schemas.openxmlformats.org/officeDocument/2006/relationships/image" Target="../media/image43.png"/><Relationship Id="rId23" Type="http://schemas.openxmlformats.org/officeDocument/2006/relationships/image" Target="../media/image44.jpeg"/><Relationship Id="rId24" Type="http://schemas.openxmlformats.org/officeDocument/2006/relationships/image" Target="../media/image43.png"/><Relationship Id="rId2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4"/>
          <p:cNvSpPr/>
          <p:nvPr/>
        </p:nvSpPr>
        <p:spPr>
          <a:xfrm>
            <a:off x="6553080" y="3270240"/>
            <a:ext cx="2384640" cy="176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 S5.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Sub-cellular localization of the full-length and truncated versions of three proteins involved in </a:t>
            </a:r>
            <a:r>
              <a:rPr b="1" i="1" lang="en-GB" sz="1400" spc="-1" strike="noStrike">
                <a:solidFill>
                  <a:srgbClr val="000000"/>
                </a:solidFill>
                <a:latin typeface="Times New Roman"/>
              </a:rPr>
              <a:t>Pik-h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-mediated resistanc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A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Pikh-1 and a GFP alone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25"/>
          <p:cNvGrpSpPr/>
          <p:nvPr/>
        </p:nvGrpSpPr>
        <p:grpSpPr>
          <a:xfrm>
            <a:off x="6932520" y="873000"/>
            <a:ext cx="1180800" cy="1989720"/>
            <a:chOff x="6932520" y="873000"/>
            <a:chExt cx="1180800" cy="1989720"/>
          </a:xfrm>
        </p:grpSpPr>
        <p:grpSp>
          <p:nvGrpSpPr>
            <p:cNvPr id="43" name="Group 26"/>
            <p:cNvGrpSpPr/>
            <p:nvPr/>
          </p:nvGrpSpPr>
          <p:grpSpPr>
            <a:xfrm>
              <a:off x="6954120" y="903960"/>
              <a:ext cx="617040" cy="1958760"/>
              <a:chOff x="6954120" y="903960"/>
              <a:chExt cx="617040" cy="1958760"/>
            </a:xfrm>
          </p:grpSpPr>
          <p:sp>
            <p:nvSpPr>
              <p:cNvPr id="44" name="AutoShape 27"/>
              <p:cNvSpPr/>
              <p:nvPr/>
            </p:nvSpPr>
            <p:spPr>
              <a:xfrm>
                <a:off x="7007400" y="2209680"/>
                <a:ext cx="482760" cy="653040"/>
              </a:xfrm>
              <a:prstGeom prst="can">
                <a:avLst>
                  <a:gd name="adj" fmla="val 25000"/>
                </a:avLst>
              </a:prstGeom>
              <a:solidFill>
                <a:srgbClr val="00ff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Line 28"/>
              <p:cNvSpPr/>
              <p:nvPr/>
            </p:nvSpPr>
            <p:spPr>
              <a:xfrm>
                <a:off x="7168320" y="2209680"/>
                <a:ext cx="161280" cy="1764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ine 29"/>
              <p:cNvSpPr/>
              <p:nvPr/>
            </p:nvSpPr>
            <p:spPr>
              <a:xfrm flipH="1">
                <a:off x="7155000" y="2380680"/>
                <a:ext cx="160560" cy="466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 Box 30"/>
              <p:cNvSpPr/>
              <p:nvPr/>
            </p:nvSpPr>
            <p:spPr>
              <a:xfrm>
                <a:off x="6954120" y="2349720"/>
                <a:ext cx="402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Y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 Box 31"/>
              <p:cNvSpPr/>
              <p:nvPr/>
            </p:nvSpPr>
            <p:spPr>
              <a:xfrm>
                <a:off x="7170480" y="2536200"/>
                <a:ext cx="400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Y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Line 32"/>
              <p:cNvSpPr/>
              <p:nvPr/>
            </p:nvSpPr>
            <p:spPr>
              <a:xfrm>
                <a:off x="7114680" y="1914480"/>
                <a:ext cx="0" cy="37260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33"/>
              <p:cNvSpPr/>
              <p:nvPr/>
            </p:nvSpPr>
            <p:spPr>
              <a:xfrm>
                <a:off x="7383240" y="1914480"/>
                <a:ext cx="0" cy="37260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34"/>
              <p:cNvSpPr/>
              <p:nvPr/>
            </p:nvSpPr>
            <p:spPr>
              <a:xfrm>
                <a:off x="7034760" y="903960"/>
                <a:ext cx="160560" cy="1026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35"/>
              <p:cNvSpPr/>
              <p:nvPr/>
            </p:nvSpPr>
            <p:spPr>
              <a:xfrm>
                <a:off x="7302600" y="903960"/>
                <a:ext cx="160560" cy="1026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36"/>
              <p:cNvSpPr/>
              <p:nvPr/>
            </p:nvSpPr>
            <p:spPr>
              <a:xfrm>
                <a:off x="7195320" y="1183680"/>
                <a:ext cx="10548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37"/>
              <p:cNvSpPr/>
              <p:nvPr/>
            </p:nvSpPr>
            <p:spPr>
              <a:xfrm>
                <a:off x="7195320" y="1276560"/>
                <a:ext cx="10548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38"/>
              <p:cNvSpPr/>
              <p:nvPr/>
            </p:nvSpPr>
            <p:spPr>
              <a:xfrm>
                <a:off x="7195320" y="1370160"/>
                <a:ext cx="10548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39"/>
              <p:cNvSpPr/>
              <p:nvPr/>
            </p:nvSpPr>
            <p:spPr>
              <a:xfrm>
                <a:off x="7195320" y="1463400"/>
                <a:ext cx="10548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40"/>
              <p:cNvSpPr/>
              <p:nvPr/>
            </p:nvSpPr>
            <p:spPr>
              <a:xfrm>
                <a:off x="7195320" y="1556640"/>
                <a:ext cx="10548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41"/>
              <p:cNvSpPr/>
              <p:nvPr/>
            </p:nvSpPr>
            <p:spPr>
              <a:xfrm>
                <a:off x="7195320" y="1649880"/>
                <a:ext cx="10548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Text Box 42"/>
            <p:cNvSpPr/>
            <p:nvPr/>
          </p:nvSpPr>
          <p:spPr>
            <a:xfrm flipV="1">
              <a:off x="6932520" y="882360"/>
              <a:ext cx="362880" cy="88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rotein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43"/>
            <p:cNvSpPr/>
            <p:nvPr/>
          </p:nvSpPr>
          <p:spPr>
            <a:xfrm flipV="1">
              <a:off x="7197480" y="873000"/>
              <a:ext cx="362880" cy="88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rotein 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Group 44"/>
            <p:cNvGrpSpPr/>
            <p:nvPr/>
          </p:nvGrpSpPr>
          <p:grpSpPr>
            <a:xfrm>
              <a:off x="7551360" y="966240"/>
              <a:ext cx="482760" cy="1861560"/>
              <a:chOff x="7551360" y="966240"/>
              <a:chExt cx="482760" cy="1861560"/>
            </a:xfrm>
          </p:grpSpPr>
          <p:sp>
            <p:nvSpPr>
              <p:cNvPr id="62" name="AutoShape 45"/>
              <p:cNvSpPr/>
              <p:nvPr/>
            </p:nvSpPr>
            <p:spPr>
              <a:xfrm>
                <a:off x="7551360" y="966240"/>
                <a:ext cx="482760" cy="652680"/>
              </a:xfrm>
              <a:prstGeom prst="can">
                <a:avLst>
                  <a:gd name="adj" fmla="val 25000"/>
                </a:avLst>
              </a:prstGeom>
              <a:solidFill>
                <a:srgbClr val="ff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46"/>
              <p:cNvSpPr/>
              <p:nvPr/>
            </p:nvSpPr>
            <p:spPr>
              <a:xfrm>
                <a:off x="7785720" y="1609200"/>
                <a:ext cx="0" cy="25056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47"/>
              <p:cNvSpPr/>
              <p:nvPr/>
            </p:nvSpPr>
            <p:spPr>
              <a:xfrm>
                <a:off x="7691760" y="1864080"/>
                <a:ext cx="187560" cy="9637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Text Box 48"/>
              <p:cNvSpPr/>
              <p:nvPr/>
            </p:nvSpPr>
            <p:spPr>
              <a:xfrm flipV="1">
                <a:off x="7604640" y="1743480"/>
                <a:ext cx="362880" cy="979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RF19IV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6" name="Text Box 49"/>
            <p:cNvSpPr/>
            <p:nvPr/>
          </p:nvSpPr>
          <p:spPr>
            <a:xfrm>
              <a:off x="7464240" y="1152720"/>
              <a:ext cx="649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mCherr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组 48"/>
          <p:cNvGrpSpPr/>
          <p:nvPr/>
        </p:nvGrpSpPr>
        <p:grpSpPr>
          <a:xfrm>
            <a:off x="1000080" y="574560"/>
            <a:ext cx="5334120" cy="5678640"/>
            <a:chOff x="1000080" y="574560"/>
            <a:chExt cx="5334120" cy="5678640"/>
          </a:xfrm>
        </p:grpSpPr>
        <p:grpSp>
          <p:nvGrpSpPr>
            <p:cNvPr id="68" name="组合 48"/>
            <p:cNvGrpSpPr/>
            <p:nvPr/>
          </p:nvGrpSpPr>
          <p:grpSpPr>
            <a:xfrm>
              <a:off x="1000080" y="850680"/>
              <a:ext cx="848520" cy="4751640"/>
              <a:chOff x="1000080" y="850680"/>
              <a:chExt cx="848520" cy="4751640"/>
            </a:xfrm>
          </p:grpSpPr>
          <p:sp>
            <p:nvSpPr>
              <p:cNvPr id="69" name="Text Box 9"/>
              <p:cNvSpPr/>
              <p:nvPr/>
            </p:nvSpPr>
            <p:spPr>
              <a:xfrm>
                <a:off x="1013760" y="3098880"/>
                <a:ext cx="82800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1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NB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 Box 10"/>
              <p:cNvSpPr/>
              <p:nvPr/>
            </p:nvSpPr>
            <p:spPr>
              <a:xfrm>
                <a:off x="1000080" y="4150800"/>
                <a:ext cx="82800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1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LR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 Box 12"/>
              <p:cNvSpPr/>
              <p:nvPr/>
            </p:nvSpPr>
            <p:spPr>
              <a:xfrm>
                <a:off x="1065240" y="1959480"/>
                <a:ext cx="75600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1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C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 Box 39"/>
              <p:cNvSpPr/>
              <p:nvPr/>
            </p:nvSpPr>
            <p:spPr>
              <a:xfrm>
                <a:off x="1272240" y="5325840"/>
                <a:ext cx="576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eGF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 Box 11"/>
              <p:cNvSpPr/>
              <p:nvPr/>
            </p:nvSpPr>
            <p:spPr>
              <a:xfrm>
                <a:off x="1072080" y="850680"/>
                <a:ext cx="75600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1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F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4" name="组合 35"/>
            <p:cNvGrpSpPr/>
            <p:nvPr/>
          </p:nvGrpSpPr>
          <p:grpSpPr>
            <a:xfrm>
              <a:off x="1766160" y="574560"/>
              <a:ext cx="4568040" cy="5678640"/>
              <a:chOff x="1766160" y="574560"/>
              <a:chExt cx="4568040" cy="5678640"/>
            </a:xfrm>
          </p:grpSpPr>
          <p:sp>
            <p:nvSpPr>
              <p:cNvPr id="75" name="Text Box 206"/>
              <p:cNvSpPr/>
              <p:nvPr/>
            </p:nvSpPr>
            <p:spPr>
              <a:xfrm>
                <a:off x="1981080" y="590760"/>
                <a:ext cx="579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eGF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 Box 207"/>
              <p:cNvSpPr/>
              <p:nvPr/>
            </p:nvSpPr>
            <p:spPr>
              <a:xfrm>
                <a:off x="2923920" y="574560"/>
                <a:ext cx="79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mCherr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Text Box 208"/>
              <p:cNvSpPr/>
              <p:nvPr/>
            </p:nvSpPr>
            <p:spPr>
              <a:xfrm>
                <a:off x="5345640" y="588960"/>
                <a:ext cx="720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Merg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 Box 209"/>
              <p:cNvSpPr/>
              <p:nvPr/>
            </p:nvSpPr>
            <p:spPr>
              <a:xfrm>
                <a:off x="4297320" y="585360"/>
                <a:ext cx="576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Ligh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9" name="Picture 227" descr="C:\Documents and Settings\Administrator\桌面\2013.8.18-zhai\附图原图_88639\附图原图\6Series170 KH1-FL-2011.6.17.tif"/>
              <p:cNvPicPr/>
              <p:nvPr/>
            </p:nvPicPr>
            <p:blipFill>
              <a:blip r:embed="rId1"/>
              <a:srcRect l="0" t="0" r="50890" b="53441"/>
              <a:stretch/>
            </p:blipFill>
            <p:spPr>
              <a:xfrm>
                <a:off x="1766160" y="845280"/>
                <a:ext cx="110988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0" name="Picture 227" descr="C:\Documents and Settings\Administrator\桌面\2013.8.18-zhai\附图原图_88639\附图原图\6Series170 KH1-FL-2011.6.17.tif"/>
              <p:cNvPicPr/>
              <p:nvPr/>
            </p:nvPicPr>
            <p:blipFill>
              <a:blip r:embed="rId2"/>
              <a:srcRect l="49698" t="50817" r="2472" b="2643"/>
              <a:stretch/>
            </p:blipFill>
            <p:spPr>
              <a:xfrm>
                <a:off x="5216040" y="84888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1" name="Picture 227" descr="C:\Documents and Settings\Administrator\桌面\2013.8.18-zhai\附图原图_88639\附图原图\6Series170 KH1-FL-2011.6.17.tif"/>
              <p:cNvPicPr/>
              <p:nvPr/>
            </p:nvPicPr>
            <p:blipFill>
              <a:blip r:embed="rId3"/>
              <a:srcRect l="49465" t="0" r="2628" b="53441"/>
              <a:stretch/>
            </p:blipFill>
            <p:spPr>
              <a:xfrm>
                <a:off x="4062240" y="84708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2" name="Picture 227" descr="C:\Documents and Settings\Administrator\桌面\2013.8.18-zhai\附图原图_88639\附图原图\6Series170 KH1-FL-2011.6.17.tif"/>
              <p:cNvPicPr/>
              <p:nvPr/>
            </p:nvPicPr>
            <p:blipFill>
              <a:blip r:embed="rId4"/>
              <a:srcRect l="0" t="50817" r="50423" b="2643"/>
              <a:stretch/>
            </p:blipFill>
            <p:spPr>
              <a:xfrm>
                <a:off x="2914200" y="84528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3" name="Picture 228" descr="C:\Documents and Settings\Administrator\桌面\2013.8.18-zhai\附图原图_88639\附图原图\3Series110KH1CC  -2011.6.17.tif"/>
              <p:cNvPicPr/>
              <p:nvPr/>
            </p:nvPicPr>
            <p:blipFill>
              <a:blip r:embed="rId5"/>
              <a:srcRect l="0" t="55039" r="53442" b="2632"/>
              <a:stretch/>
            </p:blipFill>
            <p:spPr>
              <a:xfrm>
                <a:off x="2914200" y="192420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4" name="Picture 228" descr="C:\Documents and Settings\Administrator\桌面\2013.8.18-zhai\附图原图_88639\附图原图\3Series110KH1CC  -2011.6.17.tif"/>
              <p:cNvPicPr/>
              <p:nvPr/>
            </p:nvPicPr>
            <p:blipFill>
              <a:blip r:embed="rId6"/>
              <a:srcRect l="0" t="4231" r="53442" b="53448"/>
              <a:stretch/>
            </p:blipFill>
            <p:spPr>
              <a:xfrm>
                <a:off x="1766160" y="192420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5" name="Picture 228" descr="C:\Documents and Settings\Administrator\桌面\2013.8.18-zhai\附图原图_88639\附图原图\3Series110KH1CC  -2011.6.17.tif"/>
              <p:cNvPicPr/>
              <p:nvPr/>
            </p:nvPicPr>
            <p:blipFill>
              <a:blip r:embed="rId7"/>
              <a:srcRect l="50813" t="55039" r="2629" b="2632"/>
              <a:stretch/>
            </p:blipFill>
            <p:spPr>
              <a:xfrm>
                <a:off x="5216040" y="192996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6" name="Picture 228" descr="C:\Documents and Settings\Administrator\桌面\2013.8.18-zhai\附图原图_88639\附图原图\3Series110KH1CC  -2011.6.17.tif"/>
              <p:cNvPicPr/>
              <p:nvPr/>
            </p:nvPicPr>
            <p:blipFill>
              <a:blip r:embed="rId8"/>
              <a:srcRect l="50813" t="4231" r="2629" b="53440"/>
              <a:stretch/>
            </p:blipFill>
            <p:spPr>
              <a:xfrm>
                <a:off x="4062240" y="192420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7" name="Picture 229" descr="C:\Documents and Settings\Administrator\桌面\2013.8.18-zhai\附图原图_88639\附图原图\Series032 kh1-NBS-2011.5.28.tif"/>
              <p:cNvPicPr/>
              <p:nvPr/>
            </p:nvPicPr>
            <p:blipFill>
              <a:blip r:embed="rId9"/>
              <a:srcRect l="8467" t="8467" r="57667" b="57671"/>
              <a:stretch/>
            </p:blipFill>
            <p:spPr>
              <a:xfrm>
                <a:off x="1766160" y="301608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8" name="Picture 229" descr="C:\Documents and Settings\Administrator\桌面\2013.8.18-zhai\附图原图_88639\附图原图\Series032 kh1-NBS-2011.5.28.tif"/>
              <p:cNvPicPr/>
              <p:nvPr/>
            </p:nvPicPr>
            <p:blipFill>
              <a:blip r:embed="rId10"/>
              <a:srcRect l="8470" t="59268" r="57671" b="6867"/>
              <a:stretch/>
            </p:blipFill>
            <p:spPr>
              <a:xfrm>
                <a:off x="2914200" y="301608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9" name="Picture 229" descr="C:\Documents and Settings\Administrator\桌面\2013.8.18-zhai\附图原图_88639\附图原图\Series032 kh1-NBS-2011.5.28.tif"/>
              <p:cNvPicPr/>
              <p:nvPr/>
            </p:nvPicPr>
            <p:blipFill>
              <a:blip r:embed="rId11"/>
              <a:srcRect l="56723" t="8470" r="6867" b="57671"/>
              <a:stretch/>
            </p:blipFill>
            <p:spPr>
              <a:xfrm>
                <a:off x="4068000" y="301428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0" name="Picture 229" descr="C:\Documents and Settings\Administrator\桌面\2013.8.18-zhai\附图原图_88639\附图原图\Series032 kh1-NBS-2011.5.28.tif"/>
              <p:cNvPicPr/>
              <p:nvPr/>
            </p:nvPicPr>
            <p:blipFill>
              <a:blip r:embed="rId12"/>
              <a:srcRect l="55039" t="59268" r="6867" b="6867"/>
              <a:stretch/>
            </p:blipFill>
            <p:spPr>
              <a:xfrm>
                <a:off x="5214240" y="301428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1" name="Picture 230" descr="C:\Documents and Settings\Administrator\桌面\2013.8.18-zhai\附图原图_88639\附图原图\Series064 kh1-LRR-2011.5.28.tif"/>
              <p:cNvPicPr/>
              <p:nvPr/>
            </p:nvPicPr>
            <p:blipFill>
              <a:blip r:embed="rId13"/>
              <a:srcRect l="8467" t="8467" r="57671" b="57667"/>
              <a:stretch/>
            </p:blipFill>
            <p:spPr>
              <a:xfrm>
                <a:off x="1766160" y="410616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2" name="Picture 230" descr="C:\Documents and Settings\Administrator\桌面\2013.8.18-zhai\附图原图_88639\附图原图\Series064 kh1-LRR-2011.5.28.tif"/>
              <p:cNvPicPr/>
              <p:nvPr/>
            </p:nvPicPr>
            <p:blipFill>
              <a:blip r:embed="rId14"/>
              <a:srcRect l="8463" t="59268" r="57671" b="6867"/>
              <a:stretch/>
            </p:blipFill>
            <p:spPr>
              <a:xfrm>
                <a:off x="2919960" y="410616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3" name="Picture 230" descr="C:\Documents and Settings\Administrator\桌面\2013.8.18-zhai\附图原图_88639\附图原图\Series064 kh1-LRR-2011.5.28.tif"/>
              <p:cNvPicPr/>
              <p:nvPr/>
            </p:nvPicPr>
            <p:blipFill>
              <a:blip r:embed="rId15">
                <a:lum bright="-10000"/>
              </a:blip>
              <a:srcRect l="59268" t="8470" r="6867" b="57671"/>
              <a:stretch/>
            </p:blipFill>
            <p:spPr>
              <a:xfrm>
                <a:off x="4066200" y="411336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4" name="Picture 230" descr="C:\Documents and Settings\Administrator\桌面\2013.8.18-zhai\附图原图_88639\附图原图\Series064 kh1-LRR-2011.5.28.tif"/>
              <p:cNvPicPr/>
              <p:nvPr/>
            </p:nvPicPr>
            <p:blipFill>
              <a:blip r:embed="rId16">
                <a:lum bright="-10000"/>
              </a:blip>
              <a:srcRect l="59268" t="59268" r="6867" b="6867"/>
              <a:stretch/>
            </p:blipFill>
            <p:spPr>
              <a:xfrm>
                <a:off x="5220360" y="410976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5" name="Picture 231" descr="C:\Documents and Settings\Administrator\桌面\2013.8.18-zhai\附图原图_88639\附图原图\Image158 EGFP-CK-1.tif"/>
              <p:cNvPicPr/>
              <p:nvPr/>
            </p:nvPicPr>
            <p:blipFill>
              <a:blip r:embed="rId17"/>
              <a:srcRect l="0" t="0" r="49204" b="49210"/>
              <a:stretch/>
            </p:blipFill>
            <p:spPr>
              <a:xfrm>
                <a:off x="1766160" y="520164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6" name="Picture 231" descr="C:\Documents and Settings\Administrator\桌面\2013.8.18-zhai\附图原图_88639\附图原图\Image158 EGFP-CK-1.tif"/>
              <p:cNvPicPr/>
              <p:nvPr/>
            </p:nvPicPr>
            <p:blipFill>
              <a:blip r:embed="rId18"/>
              <a:srcRect l="50810" t="50804" r="0" b="0"/>
              <a:stretch/>
            </p:blipFill>
            <p:spPr>
              <a:xfrm>
                <a:off x="5222160" y="520164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7" name="Picture 231" descr="C:\Documents and Settings\Administrator\桌面\2013.8.18-zhai\附图原图_88639\附图原图\Image158 EGFP-CK-1.tif"/>
              <p:cNvPicPr/>
              <p:nvPr/>
            </p:nvPicPr>
            <p:blipFill>
              <a:blip r:embed="rId19"/>
              <a:srcRect l="46570" t="0" r="0" b="49210"/>
              <a:stretch/>
            </p:blipFill>
            <p:spPr>
              <a:xfrm>
                <a:off x="2926080" y="520164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8" name="Picture 231" descr="C:\Documents and Settings\Administrator\桌面\2013.8.18-zhai\附图原图_88639\附图原图\Image158 EGFP-CK-1.tif"/>
              <p:cNvPicPr/>
              <p:nvPr/>
            </p:nvPicPr>
            <p:blipFill>
              <a:blip r:embed="rId20"/>
              <a:srcRect l="0" t="50804" r="49204" b="0"/>
              <a:stretch/>
            </p:blipFill>
            <p:spPr>
              <a:xfrm>
                <a:off x="4074120" y="5201640"/>
                <a:ext cx="1112040" cy="105156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 Box 47"/>
          <p:cNvSpPr/>
          <p:nvPr/>
        </p:nvSpPr>
        <p:spPr>
          <a:xfrm>
            <a:off x="6553080" y="3657600"/>
            <a:ext cx="2411640" cy="1555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Figure S5.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Sub-cellular localization of the full-length and truncated versions of three proteins involved in </a:t>
            </a:r>
            <a:r>
              <a:rPr b="1" i="1" lang="en-GB" sz="1400" spc="-1" strike="noStrike">
                <a:solidFill>
                  <a:srgbClr val="000000"/>
                </a:solidFill>
                <a:latin typeface="Times New Roman"/>
              </a:rPr>
              <a:t>Pik-h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-mediated resistanc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B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Pikh-2 and a GFP alone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Group 49"/>
          <p:cNvGrpSpPr/>
          <p:nvPr/>
        </p:nvGrpSpPr>
        <p:grpSpPr>
          <a:xfrm>
            <a:off x="6939000" y="905040"/>
            <a:ext cx="1213920" cy="1837440"/>
            <a:chOff x="6939000" y="905040"/>
            <a:chExt cx="1213920" cy="1837440"/>
          </a:xfrm>
        </p:grpSpPr>
        <p:grpSp>
          <p:nvGrpSpPr>
            <p:cNvPr id="101" name="Group 50"/>
            <p:cNvGrpSpPr/>
            <p:nvPr/>
          </p:nvGrpSpPr>
          <p:grpSpPr>
            <a:xfrm>
              <a:off x="6990840" y="905040"/>
              <a:ext cx="580680" cy="1837440"/>
              <a:chOff x="6990840" y="905040"/>
              <a:chExt cx="580680" cy="1837440"/>
            </a:xfrm>
          </p:grpSpPr>
          <p:sp>
            <p:nvSpPr>
              <p:cNvPr id="102" name="AutoShape 51"/>
              <p:cNvSpPr/>
              <p:nvPr/>
            </p:nvSpPr>
            <p:spPr>
              <a:xfrm>
                <a:off x="7041240" y="2129760"/>
                <a:ext cx="454320" cy="612720"/>
              </a:xfrm>
              <a:prstGeom prst="can">
                <a:avLst>
                  <a:gd name="adj" fmla="val 25000"/>
                </a:avLst>
              </a:prstGeom>
              <a:solidFill>
                <a:srgbClr val="00ff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52"/>
              <p:cNvSpPr/>
              <p:nvPr/>
            </p:nvSpPr>
            <p:spPr>
              <a:xfrm>
                <a:off x="7192440" y="2129760"/>
                <a:ext cx="151560" cy="165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53"/>
              <p:cNvSpPr/>
              <p:nvPr/>
            </p:nvSpPr>
            <p:spPr>
              <a:xfrm flipH="1">
                <a:off x="7180200" y="2290320"/>
                <a:ext cx="151200" cy="4374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 Box 54"/>
              <p:cNvSpPr/>
              <p:nvPr/>
            </p:nvSpPr>
            <p:spPr>
              <a:xfrm>
                <a:off x="6990840" y="2261520"/>
                <a:ext cx="37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Y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 Box 55"/>
              <p:cNvSpPr/>
              <p:nvPr/>
            </p:nvSpPr>
            <p:spPr>
              <a:xfrm>
                <a:off x="7194240" y="2436120"/>
                <a:ext cx="377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Y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Line 56"/>
              <p:cNvSpPr/>
              <p:nvPr/>
            </p:nvSpPr>
            <p:spPr>
              <a:xfrm>
                <a:off x="7130880" y="1852920"/>
                <a:ext cx="0" cy="34956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Line 57"/>
              <p:cNvSpPr/>
              <p:nvPr/>
            </p:nvSpPr>
            <p:spPr>
              <a:xfrm>
                <a:off x="7392960" y="1852920"/>
                <a:ext cx="0" cy="34956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58"/>
              <p:cNvSpPr/>
              <p:nvPr/>
            </p:nvSpPr>
            <p:spPr>
              <a:xfrm>
                <a:off x="7053840" y="905040"/>
                <a:ext cx="151560" cy="962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59"/>
              <p:cNvSpPr/>
              <p:nvPr/>
            </p:nvSpPr>
            <p:spPr>
              <a:xfrm>
                <a:off x="7318800" y="905040"/>
                <a:ext cx="151200" cy="962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Line 60"/>
              <p:cNvSpPr/>
              <p:nvPr/>
            </p:nvSpPr>
            <p:spPr>
              <a:xfrm>
                <a:off x="7218000" y="116748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Line 61"/>
              <p:cNvSpPr/>
              <p:nvPr/>
            </p:nvSpPr>
            <p:spPr>
              <a:xfrm>
                <a:off x="7218000" y="125460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Line 62"/>
              <p:cNvSpPr/>
              <p:nvPr/>
            </p:nvSpPr>
            <p:spPr>
              <a:xfrm>
                <a:off x="7218000" y="134244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Line 63"/>
              <p:cNvSpPr/>
              <p:nvPr/>
            </p:nvSpPr>
            <p:spPr>
              <a:xfrm>
                <a:off x="7218000" y="142992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Line 64"/>
              <p:cNvSpPr/>
              <p:nvPr/>
            </p:nvSpPr>
            <p:spPr>
              <a:xfrm>
                <a:off x="7218000" y="151704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Line 65"/>
              <p:cNvSpPr/>
              <p:nvPr/>
            </p:nvSpPr>
            <p:spPr>
              <a:xfrm>
                <a:off x="7218000" y="160488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7" name="Text Box 66"/>
            <p:cNvSpPr/>
            <p:nvPr/>
          </p:nvSpPr>
          <p:spPr>
            <a:xfrm flipV="1">
              <a:off x="6939000" y="938520"/>
              <a:ext cx="362880" cy="83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rotein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67"/>
            <p:cNvSpPr/>
            <p:nvPr/>
          </p:nvSpPr>
          <p:spPr>
            <a:xfrm flipV="1">
              <a:off x="7219800" y="929520"/>
              <a:ext cx="362880" cy="83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rotein 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9" name="Group 68"/>
            <p:cNvGrpSpPr/>
            <p:nvPr/>
          </p:nvGrpSpPr>
          <p:grpSpPr>
            <a:xfrm>
              <a:off x="7534080" y="963000"/>
              <a:ext cx="503640" cy="1735560"/>
              <a:chOff x="7534080" y="963000"/>
              <a:chExt cx="503640" cy="1735560"/>
            </a:xfrm>
          </p:grpSpPr>
          <p:sp>
            <p:nvSpPr>
              <p:cNvPr id="120" name="AutoShape 69"/>
              <p:cNvSpPr/>
              <p:nvPr/>
            </p:nvSpPr>
            <p:spPr>
              <a:xfrm>
                <a:off x="7534080" y="963000"/>
                <a:ext cx="503640" cy="612360"/>
              </a:xfrm>
              <a:prstGeom prst="can">
                <a:avLst>
                  <a:gd name="adj" fmla="val 27689"/>
                </a:avLst>
              </a:prstGeom>
              <a:solidFill>
                <a:srgbClr val="ff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Line 70"/>
              <p:cNvSpPr/>
              <p:nvPr/>
            </p:nvSpPr>
            <p:spPr>
              <a:xfrm>
                <a:off x="7781760" y="1568160"/>
                <a:ext cx="0" cy="21492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71"/>
              <p:cNvSpPr/>
              <p:nvPr/>
            </p:nvSpPr>
            <p:spPr>
              <a:xfrm>
                <a:off x="7696440" y="1794240"/>
                <a:ext cx="176760" cy="904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Text Box 72"/>
              <p:cNvSpPr/>
              <p:nvPr/>
            </p:nvSpPr>
            <p:spPr>
              <a:xfrm flipV="1">
                <a:off x="7599960" y="1675800"/>
                <a:ext cx="362880" cy="918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RF19IV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4" name="Text Box 73"/>
            <p:cNvSpPr/>
            <p:nvPr/>
          </p:nvSpPr>
          <p:spPr>
            <a:xfrm>
              <a:off x="7471080" y="1137960"/>
              <a:ext cx="681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mCherr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组 47"/>
          <p:cNvGrpSpPr/>
          <p:nvPr/>
        </p:nvGrpSpPr>
        <p:grpSpPr>
          <a:xfrm>
            <a:off x="1001880" y="630360"/>
            <a:ext cx="5376600" cy="5627520"/>
            <a:chOff x="1001880" y="630360"/>
            <a:chExt cx="5376600" cy="5627520"/>
          </a:xfrm>
        </p:grpSpPr>
        <p:grpSp>
          <p:nvGrpSpPr>
            <p:cNvPr id="126" name="组合 48"/>
            <p:cNvGrpSpPr/>
            <p:nvPr/>
          </p:nvGrpSpPr>
          <p:grpSpPr>
            <a:xfrm>
              <a:off x="1001880" y="983520"/>
              <a:ext cx="853200" cy="4546800"/>
              <a:chOff x="1001880" y="983520"/>
              <a:chExt cx="853200" cy="4546800"/>
            </a:xfrm>
          </p:grpSpPr>
          <p:sp>
            <p:nvSpPr>
              <p:cNvPr id="127" name="Text Box 32"/>
              <p:cNvSpPr/>
              <p:nvPr/>
            </p:nvSpPr>
            <p:spPr>
              <a:xfrm>
                <a:off x="1077480" y="983520"/>
                <a:ext cx="75564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2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F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Text Box 35"/>
              <p:cNvSpPr/>
              <p:nvPr/>
            </p:nvSpPr>
            <p:spPr>
              <a:xfrm>
                <a:off x="1015560" y="3178440"/>
                <a:ext cx="82764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2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NB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Text Box 36"/>
              <p:cNvSpPr/>
              <p:nvPr/>
            </p:nvSpPr>
            <p:spPr>
              <a:xfrm>
                <a:off x="1001880" y="4182840"/>
                <a:ext cx="82764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2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LR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Text Box 37"/>
              <p:cNvSpPr/>
              <p:nvPr/>
            </p:nvSpPr>
            <p:spPr>
              <a:xfrm>
                <a:off x="1057320" y="1967760"/>
                <a:ext cx="79164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2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C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Text Box 43"/>
              <p:cNvSpPr/>
              <p:nvPr/>
            </p:nvSpPr>
            <p:spPr>
              <a:xfrm>
                <a:off x="1279440" y="5253840"/>
                <a:ext cx="57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eGF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2" name="组合 36"/>
            <p:cNvGrpSpPr/>
            <p:nvPr/>
          </p:nvGrpSpPr>
          <p:grpSpPr>
            <a:xfrm>
              <a:off x="1776600" y="630360"/>
              <a:ext cx="4601880" cy="5627520"/>
              <a:chOff x="1776600" y="630360"/>
              <a:chExt cx="4601880" cy="5627520"/>
            </a:xfrm>
          </p:grpSpPr>
          <p:sp>
            <p:nvSpPr>
              <p:cNvPr id="133" name="Text Box 114"/>
              <p:cNvSpPr/>
              <p:nvPr/>
            </p:nvSpPr>
            <p:spPr>
              <a:xfrm>
                <a:off x="2053080" y="646560"/>
                <a:ext cx="57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eGF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Text Box 115"/>
              <p:cNvSpPr/>
              <p:nvPr/>
            </p:nvSpPr>
            <p:spPr>
              <a:xfrm>
                <a:off x="2977560" y="630360"/>
                <a:ext cx="791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mCherr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Text Box 116"/>
              <p:cNvSpPr/>
              <p:nvPr/>
            </p:nvSpPr>
            <p:spPr>
              <a:xfrm>
                <a:off x="5329800" y="644760"/>
                <a:ext cx="719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Merg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Text Box 117"/>
              <p:cNvSpPr/>
              <p:nvPr/>
            </p:nvSpPr>
            <p:spPr>
              <a:xfrm>
                <a:off x="4250880" y="641160"/>
                <a:ext cx="539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Ligh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37" name="Picture 137" descr="C:\Documents and Settings\Administrator\桌面\2013.8.18-zhai\附图原图_88639\附图原图\7Series266_KH2-FL-2011.6.17.tif"/>
              <p:cNvPicPr/>
              <p:nvPr/>
            </p:nvPicPr>
            <p:blipFill>
              <a:blip r:embed="rId1"/>
              <a:srcRect l="8371" t="12699" r="49215" b="49204"/>
              <a:stretch/>
            </p:blipFill>
            <p:spPr>
              <a:xfrm>
                <a:off x="1776600" y="8967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8" name="Picture 137" descr="C:\Documents and Settings\Administrator\桌面\2013.8.18-zhai\附图原图_88639\附图原图\7Series266_KH2-FL-2011.6.17.tif"/>
              <p:cNvPicPr/>
              <p:nvPr/>
            </p:nvPicPr>
            <p:blipFill>
              <a:blip r:embed="rId2"/>
              <a:srcRect l="7112" t="63502" r="49204" b="0"/>
              <a:stretch/>
            </p:blipFill>
            <p:spPr>
              <a:xfrm>
                <a:off x="2931480" y="896760"/>
                <a:ext cx="111888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9" name="Picture 137" descr="C:\Documents and Settings\Administrator\桌面\2013.8.18-zhai\附图原图_88639\附图原图\7Series266_KH2-FL-2011.6.17.tif"/>
              <p:cNvPicPr/>
              <p:nvPr/>
            </p:nvPicPr>
            <p:blipFill>
              <a:blip r:embed="rId3"/>
              <a:srcRect l="58212" t="12699" r="0" b="49204"/>
              <a:stretch/>
            </p:blipFill>
            <p:spPr>
              <a:xfrm>
                <a:off x="4092480" y="896760"/>
                <a:ext cx="111888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0" name="Picture 137" descr="C:\Documents and Settings\Administrator\桌面\2013.8.18-zhai\附图原图_88639\附图原图\7Series266_KH2-FL-2011.6.17.tif"/>
              <p:cNvPicPr/>
              <p:nvPr/>
            </p:nvPicPr>
            <p:blipFill>
              <a:blip r:embed="rId4"/>
              <a:srcRect l="57692" t="63502" r="0" b="0"/>
              <a:stretch/>
            </p:blipFill>
            <p:spPr>
              <a:xfrm>
                <a:off x="5253840" y="896760"/>
                <a:ext cx="111888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1" name="Picture 19" descr="C:\Documents and Settings\Administrator\桌面\2013.8.18-zhai\5Series038 kh2cc-2011.6.09.tif"/>
              <p:cNvPicPr/>
              <p:nvPr/>
            </p:nvPicPr>
            <p:blipFill>
              <a:blip r:embed="rId5"/>
              <a:srcRect l="4230" t="4231" r="57670" b="53448"/>
              <a:stretch/>
            </p:blipFill>
            <p:spPr>
              <a:xfrm>
                <a:off x="1776600" y="197784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2" name="Picture 19" descr="C:\Documents and Settings\Administrator\桌面\2013.8.18-zhai\5Series038 kh2cc-2011.6.09.tif"/>
              <p:cNvPicPr/>
              <p:nvPr/>
            </p:nvPicPr>
            <p:blipFill>
              <a:blip r:embed="rId6"/>
              <a:srcRect l="4230" t="55047" r="57670" b="2632"/>
              <a:stretch/>
            </p:blipFill>
            <p:spPr>
              <a:xfrm>
                <a:off x="2931480" y="197784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3" name="Picture 19" descr="C:\Documents and Settings\Administrator\桌面\2013.8.18-zhai\5Series038 kh2cc-2011.6.09.tif"/>
              <p:cNvPicPr/>
              <p:nvPr/>
            </p:nvPicPr>
            <p:blipFill>
              <a:blip r:embed="rId7"/>
              <a:srcRect l="55036" t="4231" r="6864" b="53440"/>
              <a:stretch/>
            </p:blipFill>
            <p:spPr>
              <a:xfrm>
                <a:off x="4086720" y="197784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4" name="Picture 19" descr="C:\Documents and Settings\Administrator\桌面\2013.8.18-zhai\5Series038 kh2cc-2011.6.09.tif"/>
              <p:cNvPicPr/>
              <p:nvPr/>
            </p:nvPicPr>
            <p:blipFill>
              <a:blip r:embed="rId8"/>
              <a:srcRect l="55036" t="55039" r="6864" b="2632"/>
              <a:stretch/>
            </p:blipFill>
            <p:spPr>
              <a:xfrm>
                <a:off x="5253840" y="198324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5" name="Picture 20" descr="C:\Documents and Settings\Administrator\桌面\2013.8.18-zhai\附图原图_88639\附图原图\2Series056 kh2-NBS-2011.6.17.tif"/>
              <p:cNvPicPr/>
              <p:nvPr/>
            </p:nvPicPr>
            <p:blipFill>
              <a:blip r:embed="rId9"/>
              <a:srcRect l="6086" t="16933" r="57671" b="53433"/>
              <a:stretch/>
            </p:blipFill>
            <p:spPr>
              <a:xfrm>
                <a:off x="1776600" y="30585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6" name="Picture 20" descr="C:\Documents and Settings\Administrator\桌面\2013.8.18-zhai\附图原图_88639\附图原图\2Series056 kh2-NBS-2011.6.17.tif"/>
              <p:cNvPicPr/>
              <p:nvPr/>
            </p:nvPicPr>
            <p:blipFill>
              <a:blip r:embed="rId10"/>
              <a:srcRect l="6349" t="63503" r="57671" b="2632"/>
              <a:stretch/>
            </p:blipFill>
            <p:spPr>
              <a:xfrm>
                <a:off x="2931480" y="30585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7" name="Picture 20" descr="C:\Documents and Settings\Administrator\桌面\2013.8.18-zhai\附图原图_88639\附图原图\2Series056 kh2-NBS-2011.6.17.tif"/>
              <p:cNvPicPr/>
              <p:nvPr/>
            </p:nvPicPr>
            <p:blipFill>
              <a:blip r:embed="rId11"/>
              <a:srcRect l="57154" t="12698" r="6867" b="53436"/>
              <a:stretch/>
            </p:blipFill>
            <p:spPr>
              <a:xfrm>
                <a:off x="4086720" y="30585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8" name="Picture 20" descr="C:\Documents and Settings\Administrator\桌面\2013.8.18-zhai\附图原图_88639\附图原图\2Series056 kh2-NBS-2011.6.17.tif"/>
              <p:cNvPicPr/>
              <p:nvPr/>
            </p:nvPicPr>
            <p:blipFill>
              <a:blip r:embed="rId12"/>
              <a:srcRect l="56885" t="63503" r="6867" b="2632"/>
              <a:stretch/>
            </p:blipFill>
            <p:spPr>
              <a:xfrm>
                <a:off x="5253840" y="30585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9" name="Picture 21" descr="C:\Documents and Settings\Administrator\桌面\2013.8.18-zhai\附图原图_88639\附图原图\3Series079 kh2-LRR-2011.6.17.tif"/>
              <p:cNvPicPr/>
              <p:nvPr/>
            </p:nvPicPr>
            <p:blipFill>
              <a:blip r:embed="rId13"/>
              <a:srcRect l="0" t="8466" r="57672" b="53437"/>
              <a:stretch/>
            </p:blipFill>
            <p:spPr>
              <a:xfrm>
                <a:off x="1776600" y="413964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0" name="Picture 21" descr="C:\Documents and Settings\Administrator\桌面\2013.8.18-zhai\附图原图_88639\附图原图\3Series079 kh2-LRR-2011.6.17.tif"/>
              <p:cNvPicPr/>
              <p:nvPr/>
            </p:nvPicPr>
            <p:blipFill>
              <a:blip r:embed="rId14"/>
              <a:srcRect l="0" t="59276" r="57672" b="2627"/>
              <a:stretch/>
            </p:blipFill>
            <p:spPr>
              <a:xfrm>
                <a:off x="2931480" y="413964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1" name="Picture 21" descr="C:\Documents and Settings\Administrator\桌面\2013.8.18-zhai\附图原图_88639\附图原图\3Series079 kh2-LRR-2011.6.17.tif"/>
              <p:cNvPicPr/>
              <p:nvPr/>
            </p:nvPicPr>
            <p:blipFill>
              <a:blip r:embed="rId15"/>
              <a:srcRect l="50801" t="8466" r="6871" b="53437"/>
              <a:stretch/>
            </p:blipFill>
            <p:spPr>
              <a:xfrm>
                <a:off x="4086720" y="413964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2" name="Picture 21" descr="C:\Documents and Settings\Administrator\桌面\2013.8.18-zhai\附图原图_88639\附图原图\3Series079 kh2-LRR-2011.6.17.tif"/>
              <p:cNvPicPr/>
              <p:nvPr/>
            </p:nvPicPr>
            <p:blipFill>
              <a:blip r:embed="rId16"/>
              <a:srcRect l="50801" t="59276" r="6871" b="2627"/>
              <a:stretch/>
            </p:blipFill>
            <p:spPr>
              <a:xfrm>
                <a:off x="5253840" y="413964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3" name="Picture 22" descr="C:\Documents and Settings\Administrator\桌面\2013.8.18-zhai\附图原图_88639\附图原图\Image176 EGFP-CK-2-2012.9.1.tif"/>
              <p:cNvPicPr/>
              <p:nvPr/>
            </p:nvPicPr>
            <p:blipFill>
              <a:blip r:embed="rId17"/>
              <a:srcRect l="0" t="0" r="49204" b="53441"/>
              <a:stretch/>
            </p:blipFill>
            <p:spPr>
              <a:xfrm>
                <a:off x="1776600" y="52203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4" name="Picture 22" descr="C:\Documents and Settings\Administrator\桌面\2013.8.18-zhai\附图原图_88639\附图原图\Image176 EGFP-CK-2-2012.9.1.tif"/>
              <p:cNvPicPr/>
              <p:nvPr/>
            </p:nvPicPr>
            <p:blipFill>
              <a:blip r:embed="rId18"/>
              <a:srcRect l="50810" t="46569" r="0" b="2641"/>
              <a:stretch/>
            </p:blipFill>
            <p:spPr>
              <a:xfrm>
                <a:off x="5259960" y="52203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5" name="Picture 22" descr="C:\Documents and Settings\Administrator\桌面\2013.8.18-zhai\附图原图_88639\附图原图\Image176 EGFP-CK-2-2012.9.1.tif"/>
              <p:cNvPicPr/>
              <p:nvPr/>
            </p:nvPicPr>
            <p:blipFill>
              <a:blip r:embed="rId19"/>
              <a:srcRect l="50810" t="0" r="0" b="53441"/>
              <a:stretch/>
            </p:blipFill>
            <p:spPr>
              <a:xfrm>
                <a:off x="2931480" y="52203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6" name="Picture 22" descr="C:\Documents and Settings\Administrator\桌面\2013.8.18-zhai\附图原图_88639\附图原图\Image176 EGFP-CK-2-2012.9.1.tif"/>
              <p:cNvPicPr/>
              <p:nvPr/>
            </p:nvPicPr>
            <p:blipFill>
              <a:blip r:embed="rId20"/>
              <a:srcRect l="0" t="46569" r="49204" b="2641"/>
              <a:stretch/>
            </p:blipFill>
            <p:spPr>
              <a:xfrm>
                <a:off x="4086720" y="5220360"/>
                <a:ext cx="1118520" cy="103752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Text Box 22"/>
          <p:cNvSpPr/>
          <p:nvPr/>
        </p:nvSpPr>
        <p:spPr>
          <a:xfrm>
            <a:off x="838080" y="4191120"/>
            <a:ext cx="7108920" cy="91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 S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5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Sub-cellular localization of the full-length and truncated versions of three proteins involved in </a:t>
            </a:r>
            <a:r>
              <a:rPr b="1" i="1" lang="en-GB" sz="1400" spc="-1" strike="noStrike">
                <a:solidFill>
                  <a:srgbClr val="000000"/>
                </a:solidFill>
                <a:latin typeface="Times New Roman"/>
              </a:rPr>
              <a:t>Pik-h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-mediated resistanc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C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AvrPik-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8" name="组 1"/>
          <p:cNvGrpSpPr/>
          <p:nvPr/>
        </p:nvGrpSpPr>
        <p:grpSpPr>
          <a:xfrm>
            <a:off x="539640" y="687240"/>
            <a:ext cx="6757920" cy="3329280"/>
            <a:chOff x="539640" y="687240"/>
            <a:chExt cx="6757920" cy="3329280"/>
          </a:xfrm>
        </p:grpSpPr>
        <p:sp>
          <p:nvSpPr>
            <p:cNvPr id="159" name="Text Box 20"/>
            <p:cNvSpPr/>
            <p:nvPr/>
          </p:nvSpPr>
          <p:spPr>
            <a:xfrm>
              <a:off x="702720" y="964440"/>
              <a:ext cx="93564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vrPik-h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F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21"/>
            <p:cNvSpPr/>
            <p:nvPr/>
          </p:nvSpPr>
          <p:spPr>
            <a:xfrm>
              <a:off x="539640" y="2654280"/>
              <a:ext cx="107964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vrPik-h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22-1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1" name="Picture 2" descr="C:\Documents and Settings\Administrator\桌面\2013.8.18-zhai\附图原图_88639\附图原图\Image506 avrpikh-fl-2012-9-1.tif"/>
            <p:cNvPicPr/>
            <p:nvPr/>
          </p:nvPicPr>
          <p:blipFill>
            <a:blip r:embed="rId1"/>
            <a:srcRect l="0" t="0" r="49205" b="53436"/>
            <a:stretch/>
          </p:blipFill>
          <p:spPr>
            <a:xfrm>
              <a:off x="1532520" y="960840"/>
              <a:ext cx="1403280" cy="150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2" name="Picture 2" descr="C:\Documents and Settings\Administrator\桌面\2013.8.18-zhai\附图原图_88639\附图原图\Image506 avrpikh-fl-2012-9-1.tif"/>
            <p:cNvPicPr/>
            <p:nvPr/>
          </p:nvPicPr>
          <p:blipFill>
            <a:blip r:embed="rId2"/>
            <a:srcRect l="0" t="50803" r="53436" b="2633"/>
            <a:stretch/>
          </p:blipFill>
          <p:spPr>
            <a:xfrm>
              <a:off x="4445280" y="960840"/>
              <a:ext cx="1403280" cy="1504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3" name="Text Box 206"/>
            <p:cNvSpPr/>
            <p:nvPr/>
          </p:nvSpPr>
          <p:spPr>
            <a:xfrm>
              <a:off x="1876680" y="687240"/>
              <a:ext cx="61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 Box 207"/>
            <p:cNvSpPr/>
            <p:nvPr/>
          </p:nvSpPr>
          <p:spPr>
            <a:xfrm>
              <a:off x="3240000" y="705600"/>
              <a:ext cx="88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mCherr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208"/>
            <p:cNvSpPr/>
            <p:nvPr/>
          </p:nvSpPr>
          <p:spPr>
            <a:xfrm>
              <a:off x="6065280" y="708120"/>
              <a:ext cx="771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Merg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 Box 209"/>
            <p:cNvSpPr/>
            <p:nvPr/>
          </p:nvSpPr>
          <p:spPr>
            <a:xfrm>
              <a:off x="4742280" y="702720"/>
              <a:ext cx="655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igh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7" name="Picture 2" descr="C:\Documents and Settings\Administrator\桌面\2013.8.18-zhai\附图原图_88639\附图原图\Image506 avrpikh-fl-2012-9-1.tif"/>
            <p:cNvPicPr/>
            <p:nvPr/>
          </p:nvPicPr>
          <p:blipFill>
            <a:blip r:embed="rId3"/>
            <a:srcRect l="55033" t="0" r="0" b="53436"/>
            <a:stretch/>
          </p:blipFill>
          <p:spPr>
            <a:xfrm>
              <a:off x="2996280" y="960840"/>
              <a:ext cx="1403280" cy="150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8" name="Picture 2" descr="C:\Documents and Settings\Administrator\桌面\2013.8.18-zhai\附图原图_88639\附图原图\Image506 avrpikh-fl-2012-9-1.tif"/>
            <p:cNvPicPr/>
            <p:nvPr/>
          </p:nvPicPr>
          <p:blipFill>
            <a:blip r:embed="rId4"/>
            <a:srcRect l="50803" t="50803" r="0" b="2633"/>
            <a:stretch/>
          </p:blipFill>
          <p:spPr>
            <a:xfrm>
              <a:off x="5894280" y="960840"/>
              <a:ext cx="1403280" cy="150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9" name="Picture 3" descr="C:\Documents and Settings\Administrator\桌面\2013.8.18-zhai\附图原图_88639\附图原图\Image533_avrpik-22-113-2012-9-1.tif"/>
            <p:cNvPicPr/>
            <p:nvPr/>
          </p:nvPicPr>
          <p:blipFill>
            <a:blip r:embed="rId5"/>
            <a:srcRect l="0" t="8468" r="49205" b="49205"/>
            <a:stretch/>
          </p:blipFill>
          <p:spPr>
            <a:xfrm>
              <a:off x="1532520" y="2512440"/>
              <a:ext cx="1403280" cy="150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Picture 3" descr="C:\Documents and Settings\Administrator\桌面\2013.8.18-zhai\附图原图_88639\附图原图\Image533_avrpik-22-113-2012-9-1.tif"/>
            <p:cNvPicPr/>
            <p:nvPr/>
          </p:nvPicPr>
          <p:blipFill>
            <a:blip r:embed="rId6"/>
            <a:srcRect l="0" t="59271" r="49205" b="0"/>
            <a:stretch/>
          </p:blipFill>
          <p:spPr>
            <a:xfrm>
              <a:off x="4445640" y="2512440"/>
              <a:ext cx="1403280" cy="150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1" name="Picture 3" descr="C:\Documents and Settings\Administrator\桌面\2013.8.18-zhai\附图原图_88639\附图原图\Image533_avrpik-22-113-2012-9-1.tif"/>
            <p:cNvPicPr/>
            <p:nvPr/>
          </p:nvPicPr>
          <p:blipFill>
            <a:blip r:embed="rId7"/>
            <a:srcRect l="50803" t="8468" r="0" b="49205"/>
            <a:stretch/>
          </p:blipFill>
          <p:spPr>
            <a:xfrm>
              <a:off x="2996280" y="2512440"/>
              <a:ext cx="1403280" cy="150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2" name="Picture 3" descr="C:\Documents and Settings\Administrator\桌面\2013.8.18-zhai\附图原图_88639\附图原图\Image533_avrpik-22-113-2012-9-1.tif"/>
            <p:cNvPicPr/>
            <p:nvPr/>
          </p:nvPicPr>
          <p:blipFill>
            <a:blip r:embed="rId8"/>
            <a:srcRect l="50803" t="59271" r="0" b="0"/>
            <a:stretch/>
          </p:blipFill>
          <p:spPr>
            <a:xfrm>
              <a:off x="5894280" y="2512440"/>
              <a:ext cx="1403280" cy="15040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73" name="Group 49"/>
          <p:cNvGrpSpPr/>
          <p:nvPr/>
        </p:nvGrpSpPr>
        <p:grpSpPr>
          <a:xfrm>
            <a:off x="7472520" y="1133640"/>
            <a:ext cx="1213920" cy="1837440"/>
            <a:chOff x="7472520" y="1133640"/>
            <a:chExt cx="1213920" cy="1837440"/>
          </a:xfrm>
        </p:grpSpPr>
        <p:grpSp>
          <p:nvGrpSpPr>
            <p:cNvPr id="174" name="Group 50"/>
            <p:cNvGrpSpPr/>
            <p:nvPr/>
          </p:nvGrpSpPr>
          <p:grpSpPr>
            <a:xfrm>
              <a:off x="7524360" y="1133640"/>
              <a:ext cx="580680" cy="1837440"/>
              <a:chOff x="7524360" y="1133640"/>
              <a:chExt cx="580680" cy="1837440"/>
            </a:xfrm>
          </p:grpSpPr>
          <p:sp>
            <p:nvSpPr>
              <p:cNvPr id="175" name="AutoShape 51"/>
              <p:cNvSpPr/>
              <p:nvPr/>
            </p:nvSpPr>
            <p:spPr>
              <a:xfrm>
                <a:off x="7574760" y="2358360"/>
                <a:ext cx="454320" cy="612720"/>
              </a:xfrm>
              <a:prstGeom prst="can">
                <a:avLst>
                  <a:gd name="adj" fmla="val 25000"/>
                </a:avLst>
              </a:prstGeom>
              <a:solidFill>
                <a:srgbClr val="00ff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52"/>
              <p:cNvSpPr/>
              <p:nvPr/>
            </p:nvSpPr>
            <p:spPr>
              <a:xfrm>
                <a:off x="7725960" y="2358360"/>
                <a:ext cx="151560" cy="165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53"/>
              <p:cNvSpPr/>
              <p:nvPr/>
            </p:nvSpPr>
            <p:spPr>
              <a:xfrm flipH="1">
                <a:off x="7713720" y="2518920"/>
                <a:ext cx="151200" cy="4374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Text Box 54"/>
              <p:cNvSpPr/>
              <p:nvPr/>
            </p:nvSpPr>
            <p:spPr>
              <a:xfrm>
                <a:off x="7524360" y="2490120"/>
                <a:ext cx="37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Y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Text Box 55"/>
              <p:cNvSpPr/>
              <p:nvPr/>
            </p:nvSpPr>
            <p:spPr>
              <a:xfrm>
                <a:off x="7727760" y="2664720"/>
                <a:ext cx="377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Y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ine 56"/>
              <p:cNvSpPr/>
              <p:nvPr/>
            </p:nvSpPr>
            <p:spPr>
              <a:xfrm>
                <a:off x="7664400" y="2081520"/>
                <a:ext cx="0" cy="34956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Line 57"/>
              <p:cNvSpPr/>
              <p:nvPr/>
            </p:nvSpPr>
            <p:spPr>
              <a:xfrm>
                <a:off x="7926480" y="2081520"/>
                <a:ext cx="0" cy="34956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Rectangle 58"/>
              <p:cNvSpPr/>
              <p:nvPr/>
            </p:nvSpPr>
            <p:spPr>
              <a:xfrm>
                <a:off x="7587360" y="1133640"/>
                <a:ext cx="151560" cy="962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Rectangle 59"/>
              <p:cNvSpPr/>
              <p:nvPr/>
            </p:nvSpPr>
            <p:spPr>
              <a:xfrm>
                <a:off x="7852320" y="1133640"/>
                <a:ext cx="151200" cy="962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Line 60"/>
              <p:cNvSpPr/>
              <p:nvPr/>
            </p:nvSpPr>
            <p:spPr>
              <a:xfrm>
                <a:off x="7751520" y="139608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61"/>
              <p:cNvSpPr/>
              <p:nvPr/>
            </p:nvSpPr>
            <p:spPr>
              <a:xfrm>
                <a:off x="7751520" y="148320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62"/>
              <p:cNvSpPr/>
              <p:nvPr/>
            </p:nvSpPr>
            <p:spPr>
              <a:xfrm>
                <a:off x="7751520" y="157104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Line 63"/>
              <p:cNvSpPr/>
              <p:nvPr/>
            </p:nvSpPr>
            <p:spPr>
              <a:xfrm>
                <a:off x="7751520" y="165852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Line 64"/>
              <p:cNvSpPr/>
              <p:nvPr/>
            </p:nvSpPr>
            <p:spPr>
              <a:xfrm>
                <a:off x="7751520" y="174564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ine 65"/>
              <p:cNvSpPr/>
              <p:nvPr/>
            </p:nvSpPr>
            <p:spPr>
              <a:xfrm>
                <a:off x="7751520" y="1833480"/>
                <a:ext cx="993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0" name="Text Box 66"/>
            <p:cNvSpPr/>
            <p:nvPr/>
          </p:nvSpPr>
          <p:spPr>
            <a:xfrm flipV="1">
              <a:off x="7472520" y="1167120"/>
              <a:ext cx="362880" cy="83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rotein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Text Box 67"/>
            <p:cNvSpPr/>
            <p:nvPr/>
          </p:nvSpPr>
          <p:spPr>
            <a:xfrm flipV="1">
              <a:off x="7753320" y="1158120"/>
              <a:ext cx="362880" cy="83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rotein 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2" name="Group 68"/>
            <p:cNvGrpSpPr/>
            <p:nvPr/>
          </p:nvGrpSpPr>
          <p:grpSpPr>
            <a:xfrm>
              <a:off x="8067600" y="1191600"/>
              <a:ext cx="503640" cy="1735560"/>
              <a:chOff x="8067600" y="1191600"/>
              <a:chExt cx="503640" cy="1735560"/>
            </a:xfrm>
          </p:grpSpPr>
          <p:sp>
            <p:nvSpPr>
              <p:cNvPr id="193" name="AutoShape 69"/>
              <p:cNvSpPr/>
              <p:nvPr/>
            </p:nvSpPr>
            <p:spPr>
              <a:xfrm>
                <a:off x="8067600" y="1191600"/>
                <a:ext cx="503640" cy="612360"/>
              </a:xfrm>
              <a:prstGeom prst="can">
                <a:avLst>
                  <a:gd name="adj" fmla="val 27689"/>
                </a:avLst>
              </a:prstGeom>
              <a:solidFill>
                <a:srgbClr val="ff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Line 70"/>
              <p:cNvSpPr/>
              <p:nvPr/>
            </p:nvSpPr>
            <p:spPr>
              <a:xfrm>
                <a:off x="8315280" y="1796760"/>
                <a:ext cx="0" cy="21492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Rectangle 71"/>
              <p:cNvSpPr/>
              <p:nvPr/>
            </p:nvSpPr>
            <p:spPr>
              <a:xfrm>
                <a:off x="8229960" y="2022840"/>
                <a:ext cx="176760" cy="904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Text Box 72"/>
              <p:cNvSpPr/>
              <p:nvPr/>
            </p:nvSpPr>
            <p:spPr>
              <a:xfrm flipV="1">
                <a:off x="8133480" y="1904400"/>
                <a:ext cx="362880" cy="918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RF19IV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7" name="Text Box 73"/>
            <p:cNvSpPr/>
            <p:nvPr/>
          </p:nvSpPr>
          <p:spPr>
            <a:xfrm>
              <a:off x="8004600" y="1366560"/>
              <a:ext cx="681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mCherr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Text Box 217"/>
          <p:cNvSpPr/>
          <p:nvPr/>
        </p:nvSpPr>
        <p:spPr>
          <a:xfrm>
            <a:off x="6159600" y="3048120"/>
            <a:ext cx="2892240" cy="170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 S5. Sub-cellular localization of the full-length and truncated versions of three proteins involved in </a:t>
            </a:r>
            <a:r>
              <a:rPr b="1" i="1" lang="en-GB" sz="1400" spc="-1" strike="noStrike">
                <a:solidFill>
                  <a:srgbClr val="000000"/>
                </a:solidFill>
                <a:latin typeface="Times New Roman"/>
              </a:rPr>
              <a:t>Pik-h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-mediated resistanc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D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Mislocation of Pikh-1 (upper panel) and Pikh-2 (lower panel) by using NLS and NES, respectively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9" name="组 65"/>
          <p:cNvGrpSpPr/>
          <p:nvPr/>
        </p:nvGrpSpPr>
        <p:grpSpPr>
          <a:xfrm>
            <a:off x="424800" y="264960"/>
            <a:ext cx="5701320" cy="6159600"/>
            <a:chOff x="424800" y="264960"/>
            <a:chExt cx="5701320" cy="6159600"/>
          </a:xfrm>
        </p:grpSpPr>
        <p:sp>
          <p:nvSpPr>
            <p:cNvPr id="200" name="Text Box 149"/>
            <p:cNvSpPr/>
            <p:nvPr/>
          </p:nvSpPr>
          <p:spPr>
            <a:xfrm>
              <a:off x="458280" y="533160"/>
              <a:ext cx="107352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ikh-1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FL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-N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Text Box 150"/>
            <p:cNvSpPr/>
            <p:nvPr/>
          </p:nvSpPr>
          <p:spPr>
            <a:xfrm>
              <a:off x="458280" y="1419120"/>
              <a:ext cx="107352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ikh-1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FL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-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Text Box 151"/>
            <p:cNvSpPr/>
            <p:nvPr/>
          </p:nvSpPr>
          <p:spPr>
            <a:xfrm>
              <a:off x="424800" y="2471760"/>
              <a:ext cx="10890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ikh-1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CC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-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3" name="组合 41"/>
            <p:cNvGrpSpPr/>
            <p:nvPr/>
          </p:nvGrpSpPr>
          <p:grpSpPr>
            <a:xfrm>
              <a:off x="1980720" y="264960"/>
              <a:ext cx="4145400" cy="287280"/>
              <a:chOff x="1980720" y="264960"/>
              <a:chExt cx="4145400" cy="287280"/>
            </a:xfrm>
          </p:grpSpPr>
          <p:sp>
            <p:nvSpPr>
              <p:cNvPr id="204" name="Text Box 206"/>
              <p:cNvSpPr/>
              <p:nvPr/>
            </p:nvSpPr>
            <p:spPr>
              <a:xfrm>
                <a:off x="1980720" y="275760"/>
                <a:ext cx="874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eGF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Text Box 207"/>
              <p:cNvSpPr/>
              <p:nvPr/>
            </p:nvSpPr>
            <p:spPr>
              <a:xfrm>
                <a:off x="2928960" y="271080"/>
                <a:ext cx="948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mCherr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Text Box 208"/>
              <p:cNvSpPr/>
              <p:nvPr/>
            </p:nvSpPr>
            <p:spPr>
              <a:xfrm>
                <a:off x="5173920" y="264960"/>
                <a:ext cx="952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Merg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Text Box 209"/>
              <p:cNvSpPr/>
              <p:nvPr/>
            </p:nvSpPr>
            <p:spPr>
              <a:xfrm>
                <a:off x="4178160" y="271080"/>
                <a:ext cx="950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Ligh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8" name="组合 42"/>
            <p:cNvGrpSpPr/>
            <p:nvPr/>
          </p:nvGrpSpPr>
          <p:grpSpPr>
            <a:xfrm>
              <a:off x="1588320" y="519840"/>
              <a:ext cx="4530240" cy="2844360"/>
              <a:chOff x="1588320" y="519840"/>
              <a:chExt cx="4530240" cy="2844360"/>
            </a:xfrm>
          </p:grpSpPr>
          <p:sp>
            <p:nvSpPr>
              <p:cNvPr id="209" name="Line 181"/>
              <p:cNvSpPr/>
              <p:nvPr/>
            </p:nvSpPr>
            <p:spPr>
              <a:xfrm>
                <a:off x="1588320" y="2379240"/>
                <a:ext cx="4292640" cy="0"/>
              </a:xfrm>
              <a:prstGeom prst="line">
                <a:avLst/>
              </a:prstGeom>
              <a:ln w="284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Line 214"/>
              <p:cNvSpPr/>
              <p:nvPr/>
            </p:nvSpPr>
            <p:spPr>
              <a:xfrm>
                <a:off x="1712160" y="519840"/>
                <a:ext cx="0" cy="2844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11" name="Picture 2" descr="C:\Documents and Settings\Administrator\桌面\2013.8.18-zhai\附图原图_88639\附图原图\Image043 kh1-nls-2012.8.1.tif"/>
              <p:cNvPicPr/>
              <p:nvPr/>
            </p:nvPicPr>
            <p:blipFill>
              <a:blip r:embed="rId1"/>
              <a:srcRect l="4236" t="0" r="49206" b="49210"/>
              <a:stretch/>
            </p:blipFill>
            <p:spPr>
              <a:xfrm>
                <a:off x="1764000" y="52632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2" name="Picture 2" descr="C:\Documents and Settings\Administrator\桌面\2013.8.18-zhai\附图原图_88639\附图原图\Image043 kh1-nls-2012.8.1.tif"/>
              <p:cNvPicPr/>
              <p:nvPr/>
            </p:nvPicPr>
            <p:blipFill>
              <a:blip r:embed="rId2"/>
              <a:srcRect l="4236" t="50804" r="49206" b="0"/>
              <a:stretch/>
            </p:blipFill>
            <p:spPr>
              <a:xfrm>
                <a:off x="3958560" y="52632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3" name="Picture 2" descr="C:\Documents and Settings\Administrator\桌面\2013.8.18-zhai\附图原图_88639\附图原图\Image043 kh1-nls-2012.8.1.tif"/>
              <p:cNvPicPr/>
              <p:nvPr/>
            </p:nvPicPr>
            <p:blipFill>
              <a:blip r:embed="rId3"/>
              <a:srcRect l="55044" t="50804" r="0" b="0"/>
              <a:stretch/>
            </p:blipFill>
            <p:spPr>
              <a:xfrm>
                <a:off x="5055840" y="52632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4" name="Picture 2" descr="C:\Documents and Settings\Administrator\桌面\2013.8.18-zhai\附图原图_88639\附图原图\Image043 kh1-nls-2012.8.1.tif"/>
              <p:cNvPicPr/>
              <p:nvPr/>
            </p:nvPicPr>
            <p:blipFill>
              <a:blip r:embed="rId4"/>
              <a:srcRect l="55034" t="0" r="0" b="49210"/>
              <a:stretch/>
            </p:blipFill>
            <p:spPr>
              <a:xfrm>
                <a:off x="2861280" y="52632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5" name="Picture 3" descr="C:\Documents and Settings\Administrator\桌面\2013.8.18-zhai\附图原图_88639\附图原图\Image006 kh1-nes-2013.8.14Snapshot All1.tif"/>
              <p:cNvPicPr/>
              <p:nvPr/>
            </p:nvPicPr>
            <p:blipFill>
              <a:blip r:embed="rId5"/>
              <a:srcRect l="8467" t="8467" r="57671" b="61905"/>
              <a:stretch/>
            </p:blipFill>
            <p:spPr>
              <a:xfrm>
                <a:off x="1764000" y="147924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6" name="Picture 3" descr="C:\Documents and Settings\Administrator\桌面\2013.8.18-zhai\附图原图_88639\附图原图\Image006 kh1-nes-2013.8.14Snapshot All1.tif"/>
              <p:cNvPicPr/>
              <p:nvPr/>
            </p:nvPicPr>
            <p:blipFill>
              <a:blip r:embed="rId6"/>
              <a:srcRect l="8470" t="59268" r="57671" b="11101"/>
              <a:stretch/>
            </p:blipFill>
            <p:spPr>
              <a:xfrm>
                <a:off x="3958560" y="147924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7" name="Picture 3" descr="C:\Documents and Settings\Administrator\桌面\2013.8.18-zhai\附图原图_88639\附图原图\Image006 kh1-nes-2013.8.14Snapshot All1.tif"/>
              <p:cNvPicPr/>
              <p:nvPr/>
            </p:nvPicPr>
            <p:blipFill>
              <a:blip r:embed="rId7"/>
              <a:srcRect l="59271" t="8467" r="6867" b="61905"/>
              <a:stretch/>
            </p:blipFill>
            <p:spPr>
              <a:xfrm>
                <a:off x="2861280" y="147924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8" name="Picture 3" descr="C:\Documents and Settings\Administrator\桌面\2013.8.18-zhai\附图原图_88639\附图原图\Image006 kh1-nes-2013.8.14Snapshot All1.tif"/>
              <p:cNvPicPr/>
              <p:nvPr/>
            </p:nvPicPr>
            <p:blipFill>
              <a:blip r:embed="rId8"/>
              <a:srcRect l="59268" t="59268" r="6867" b="11101"/>
              <a:stretch/>
            </p:blipFill>
            <p:spPr>
              <a:xfrm>
                <a:off x="5055840" y="147924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9" name="Picture 4" descr="C:\Documents and Settings\Administrator\桌面\2013.8.18-zhai\附图原图_88639\附图原图\Image270 kh1CC-NES-2012-9-1.tif"/>
              <p:cNvPicPr/>
              <p:nvPr/>
            </p:nvPicPr>
            <p:blipFill>
              <a:blip r:embed="rId9"/>
              <a:srcRect l="0" t="50803" r="49205" b="0"/>
              <a:stretch/>
            </p:blipFill>
            <p:spPr>
              <a:xfrm>
                <a:off x="3958920" y="243180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0" name="Picture 4" descr="C:\Documents and Settings\Administrator\桌面\2013.8.18-zhai\附图原图_88639\附图原图\Image270 kh1CC-NES-2012-9-1.tif"/>
              <p:cNvPicPr/>
              <p:nvPr/>
            </p:nvPicPr>
            <p:blipFill>
              <a:blip r:embed="rId10"/>
              <a:srcRect l="0" t="0" r="49205" b="49205"/>
              <a:stretch/>
            </p:blipFill>
            <p:spPr>
              <a:xfrm>
                <a:off x="1758600" y="243180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1" name="Picture 4" descr="C:\Documents and Settings\Administrator\桌面\2013.8.18-zhai\附图原图_88639\附图原图\Image270 kh1CC-NES-2012-9-1.tif"/>
              <p:cNvPicPr/>
              <p:nvPr/>
            </p:nvPicPr>
            <p:blipFill>
              <a:blip r:embed="rId11"/>
              <a:srcRect l="50803" t="0" r="0" b="49205"/>
              <a:stretch/>
            </p:blipFill>
            <p:spPr>
              <a:xfrm>
                <a:off x="2861640" y="243180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2" name="Picture 4" descr="C:\Documents and Settings\Administrator\桌面\2013.8.18-zhai\附图原图_88639\附图原图\Image270 kh1CC-NES-2012-9-1.tif"/>
              <p:cNvPicPr/>
              <p:nvPr/>
            </p:nvPicPr>
            <p:blipFill>
              <a:blip r:embed="rId12"/>
              <a:srcRect l="50803" t="50803" r="0" b="0"/>
              <a:stretch/>
            </p:blipFill>
            <p:spPr>
              <a:xfrm>
                <a:off x="5056200" y="243180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223" name="组合 69"/>
            <p:cNvGrpSpPr/>
            <p:nvPr/>
          </p:nvGrpSpPr>
          <p:grpSpPr>
            <a:xfrm>
              <a:off x="441720" y="3580200"/>
              <a:ext cx="5680440" cy="2844360"/>
              <a:chOff x="441720" y="3580200"/>
              <a:chExt cx="5680440" cy="2844360"/>
            </a:xfrm>
          </p:grpSpPr>
          <p:sp>
            <p:nvSpPr>
              <p:cNvPr id="224" name="Text Box 211"/>
              <p:cNvSpPr/>
              <p:nvPr/>
            </p:nvSpPr>
            <p:spPr>
              <a:xfrm>
                <a:off x="461520" y="3581280"/>
                <a:ext cx="107352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2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FL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-NL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Text Box 212"/>
              <p:cNvSpPr/>
              <p:nvPr/>
            </p:nvSpPr>
            <p:spPr>
              <a:xfrm>
                <a:off x="461520" y="4583160"/>
                <a:ext cx="107352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2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FL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-N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Text Box 213"/>
              <p:cNvSpPr/>
              <p:nvPr/>
            </p:nvSpPr>
            <p:spPr>
              <a:xfrm>
                <a:off x="441720" y="5563080"/>
                <a:ext cx="1089000" cy="30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ikh-2</a:t>
                </a:r>
                <a:r>
                  <a:rPr b="1" lang="en-US" sz="1200" spc="-1" strike="noStrike" baseline="-25000">
                    <a:solidFill>
                      <a:srgbClr val="000000"/>
                    </a:solidFill>
                    <a:latin typeface="Times New Roman"/>
                  </a:rPr>
                  <a:t>CC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-N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215"/>
              <p:cNvSpPr/>
              <p:nvPr/>
            </p:nvSpPr>
            <p:spPr>
              <a:xfrm>
                <a:off x="1715760" y="3580200"/>
                <a:ext cx="0" cy="2844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28" name="Picture 5" descr="C:\Documents and Settings\Administrator\桌面\2013.8.18-zhai\附图原图_88639\附图原图\Image072 kh2-nls-2013.8.1.tif"/>
              <p:cNvPicPr/>
              <p:nvPr/>
            </p:nvPicPr>
            <p:blipFill>
              <a:blip r:embed="rId13"/>
              <a:srcRect l="4241" t="0" r="49210" b="53451"/>
              <a:stretch/>
            </p:blipFill>
            <p:spPr>
              <a:xfrm>
                <a:off x="1768320" y="358128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9" name="Picture 5" descr="C:\Documents and Settings\Administrator\桌面\2013.8.18-zhai\附图原图_88639\附图原图\Image072 kh2-nls-2013.8.1.tif"/>
              <p:cNvPicPr/>
              <p:nvPr/>
            </p:nvPicPr>
            <p:blipFill>
              <a:blip r:embed="rId14"/>
              <a:srcRect l="55051" t="50810" r="0" b="2641"/>
              <a:stretch/>
            </p:blipFill>
            <p:spPr>
              <a:xfrm>
                <a:off x="5059800" y="358128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0" name="Picture 5" descr="C:\Documents and Settings\Administrator\桌面\2013.8.18-zhai\附图原图_88639\附图原图\Image072 kh2-nls-2013.8.1.tif"/>
              <p:cNvPicPr/>
              <p:nvPr/>
            </p:nvPicPr>
            <p:blipFill>
              <a:blip r:embed="rId15"/>
              <a:srcRect l="55051" t="0" r="0" b="53451"/>
              <a:stretch/>
            </p:blipFill>
            <p:spPr>
              <a:xfrm>
                <a:off x="2865240" y="358128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1" name="Picture 5" descr="C:\Documents and Settings\Administrator\桌面\2013.8.18-zhai\附图原图_88639\附图原图\Image072 kh2-nls-2013.8.1.tif"/>
              <p:cNvPicPr/>
              <p:nvPr/>
            </p:nvPicPr>
            <p:blipFill>
              <a:blip r:embed="rId16"/>
              <a:srcRect l="4241" t="50810" r="49210" b="2641"/>
              <a:stretch/>
            </p:blipFill>
            <p:spPr>
              <a:xfrm>
                <a:off x="3962520" y="358128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2" name="Picture 6" descr="C:\Documents and Settings\Administrator\桌面\2013.8.18-zhai\附图原图_88639\附图原图\Image032 kh2-nes 2012.8.14.tif"/>
              <p:cNvPicPr/>
              <p:nvPr/>
            </p:nvPicPr>
            <p:blipFill>
              <a:blip r:embed="rId17">
                <a:lum bright="-10000"/>
              </a:blip>
              <a:srcRect l="55037" t="55044" r="2635" b="6875"/>
              <a:stretch/>
            </p:blipFill>
            <p:spPr>
              <a:xfrm>
                <a:off x="5059440" y="453384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3" name="Picture 6" descr="C:\Documents and Settings\Administrator\桌面\2013.8.18-zhai\附图原图_88639\附图原图\Image032 kh2-nes 2012.8.14.tif"/>
              <p:cNvPicPr/>
              <p:nvPr/>
            </p:nvPicPr>
            <p:blipFill>
              <a:blip r:embed="rId18"/>
              <a:srcRect l="4233" t="8467" r="53438" b="57671"/>
              <a:stretch/>
            </p:blipFill>
            <p:spPr>
              <a:xfrm>
                <a:off x="1767960" y="453384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4" name="Picture 6" descr="C:\Documents and Settings\Administrator\桌面\2013.8.18-zhai\附图原图_88639\附图原图\Image032 kh2-nes 2012.8.14.tif"/>
              <p:cNvPicPr/>
              <p:nvPr/>
            </p:nvPicPr>
            <p:blipFill>
              <a:blip r:embed="rId19"/>
              <a:srcRect l="55033" t="8467" r="2634" b="57671"/>
              <a:stretch/>
            </p:blipFill>
            <p:spPr>
              <a:xfrm>
                <a:off x="2865240" y="453384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5" name="Picture 6" descr="C:\Documents and Settings\Administrator\桌面\2013.8.18-zhai\附图原图_88639\附图原图\Image032 kh2-nes 2012.8.14.tif"/>
              <p:cNvPicPr/>
              <p:nvPr/>
            </p:nvPicPr>
            <p:blipFill>
              <a:blip r:embed="rId20">
                <a:lum bright="-10000"/>
              </a:blip>
              <a:srcRect l="4236" t="55044" r="53436" b="6875"/>
              <a:stretch/>
            </p:blipFill>
            <p:spPr>
              <a:xfrm>
                <a:off x="3962160" y="453384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6" name="Picture 7" descr="C:\Documents and Settings\Administrator\桌面\2013.8.18-zhai\附图原图_88639\附图原图\Image277-kh2cc-NES-2012-9-1.tif"/>
              <p:cNvPicPr/>
              <p:nvPr/>
            </p:nvPicPr>
            <p:blipFill>
              <a:blip r:embed="rId21"/>
              <a:srcRect l="4230" t="59271" r="49205" b="2633"/>
              <a:stretch/>
            </p:blipFill>
            <p:spPr>
              <a:xfrm>
                <a:off x="3962160" y="548676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7" name="Picture 7" descr="C:\Documents and Settings\Administrator\桌面\2013.8.18-zhai\附图原图_88639\附图原图\Image277-kh2cc-NES-2012-9-1.tif"/>
              <p:cNvPicPr/>
              <p:nvPr/>
            </p:nvPicPr>
            <p:blipFill>
              <a:blip r:embed="rId22"/>
              <a:srcRect l="4230" t="8468" r="49205" b="53436"/>
              <a:stretch/>
            </p:blipFill>
            <p:spPr>
              <a:xfrm>
                <a:off x="1767960" y="548676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8" name="Picture 7" descr="C:\Documents and Settings\Administrator\桌面\2013.8.18-zhai\附图原图_88639\附图原图\Image277-kh2cc-NES-2012-9-1.tif"/>
              <p:cNvPicPr/>
              <p:nvPr/>
            </p:nvPicPr>
            <p:blipFill>
              <a:blip r:embed="rId23"/>
              <a:srcRect l="55038" t="8468" r="0" b="53437"/>
              <a:stretch/>
            </p:blipFill>
            <p:spPr>
              <a:xfrm>
                <a:off x="2865240" y="548676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9" name="Picture 7" descr="C:\Documents and Settings\Administrator\桌面\2013.8.18-zhai\附图原图_88639\附图原图\Image277-kh2cc-NES-2012-9-1.tif"/>
              <p:cNvPicPr/>
              <p:nvPr/>
            </p:nvPicPr>
            <p:blipFill>
              <a:blip r:embed="rId24"/>
              <a:srcRect l="55033" t="59271" r="0" b="2633"/>
              <a:stretch/>
            </p:blipFill>
            <p:spPr>
              <a:xfrm>
                <a:off x="5059440" y="5486760"/>
                <a:ext cx="1062360" cy="91440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grpSp>
        <p:nvGrpSpPr>
          <p:cNvPr id="240" name="Group 49"/>
          <p:cNvGrpSpPr/>
          <p:nvPr/>
        </p:nvGrpSpPr>
        <p:grpSpPr>
          <a:xfrm>
            <a:off x="6647040" y="685800"/>
            <a:ext cx="1393200" cy="1837440"/>
            <a:chOff x="6647040" y="685800"/>
            <a:chExt cx="1393200" cy="1837440"/>
          </a:xfrm>
        </p:grpSpPr>
        <p:grpSp>
          <p:nvGrpSpPr>
            <p:cNvPr id="241" name="Group 50"/>
            <p:cNvGrpSpPr/>
            <p:nvPr/>
          </p:nvGrpSpPr>
          <p:grpSpPr>
            <a:xfrm>
              <a:off x="6647040" y="685800"/>
              <a:ext cx="696240" cy="1837440"/>
              <a:chOff x="6647040" y="685800"/>
              <a:chExt cx="696240" cy="1837440"/>
            </a:xfrm>
          </p:grpSpPr>
          <p:sp>
            <p:nvSpPr>
              <p:cNvPr id="242" name="AutoShape 51"/>
              <p:cNvSpPr/>
              <p:nvPr/>
            </p:nvSpPr>
            <p:spPr>
              <a:xfrm>
                <a:off x="6707520" y="1910520"/>
                <a:ext cx="544680" cy="612720"/>
              </a:xfrm>
              <a:prstGeom prst="can">
                <a:avLst>
                  <a:gd name="adj" fmla="val 25000"/>
                </a:avLst>
              </a:prstGeom>
              <a:solidFill>
                <a:srgbClr val="00ff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Line 52"/>
              <p:cNvSpPr/>
              <p:nvPr/>
            </p:nvSpPr>
            <p:spPr>
              <a:xfrm>
                <a:off x="6888960" y="1910520"/>
                <a:ext cx="181800" cy="165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Line 53"/>
              <p:cNvSpPr/>
              <p:nvPr/>
            </p:nvSpPr>
            <p:spPr>
              <a:xfrm flipH="1">
                <a:off x="6873840" y="2071080"/>
                <a:ext cx="181440" cy="4374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Text Box 54"/>
              <p:cNvSpPr/>
              <p:nvPr/>
            </p:nvSpPr>
            <p:spPr>
              <a:xfrm>
                <a:off x="6647040" y="2042280"/>
                <a:ext cx="45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Y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Text Box 55"/>
              <p:cNvSpPr/>
              <p:nvPr/>
            </p:nvSpPr>
            <p:spPr>
              <a:xfrm>
                <a:off x="6891120" y="2216880"/>
                <a:ext cx="45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Y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Line 56"/>
              <p:cNvSpPr/>
              <p:nvPr/>
            </p:nvSpPr>
            <p:spPr>
              <a:xfrm>
                <a:off x="6815160" y="1633680"/>
                <a:ext cx="0" cy="34956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Line 57"/>
              <p:cNvSpPr/>
              <p:nvPr/>
            </p:nvSpPr>
            <p:spPr>
              <a:xfrm>
                <a:off x="7129080" y="1633680"/>
                <a:ext cx="0" cy="34956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Rectangle 58"/>
              <p:cNvSpPr/>
              <p:nvPr/>
            </p:nvSpPr>
            <p:spPr>
              <a:xfrm>
                <a:off x="6722280" y="685800"/>
                <a:ext cx="181800" cy="962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Rectangle 59"/>
              <p:cNvSpPr/>
              <p:nvPr/>
            </p:nvSpPr>
            <p:spPr>
              <a:xfrm>
                <a:off x="7040520" y="685800"/>
                <a:ext cx="181440" cy="962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Line 60"/>
              <p:cNvSpPr/>
              <p:nvPr/>
            </p:nvSpPr>
            <p:spPr>
              <a:xfrm>
                <a:off x="6919200" y="948240"/>
                <a:ext cx="1191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Line 61"/>
              <p:cNvSpPr/>
              <p:nvPr/>
            </p:nvSpPr>
            <p:spPr>
              <a:xfrm>
                <a:off x="6919200" y="1035360"/>
                <a:ext cx="1191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Line 62"/>
              <p:cNvSpPr/>
              <p:nvPr/>
            </p:nvSpPr>
            <p:spPr>
              <a:xfrm>
                <a:off x="6919200" y="1123200"/>
                <a:ext cx="1191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Line 63"/>
              <p:cNvSpPr/>
              <p:nvPr/>
            </p:nvSpPr>
            <p:spPr>
              <a:xfrm>
                <a:off x="6919200" y="1210680"/>
                <a:ext cx="1191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Line 64"/>
              <p:cNvSpPr/>
              <p:nvPr/>
            </p:nvSpPr>
            <p:spPr>
              <a:xfrm>
                <a:off x="6919200" y="1297800"/>
                <a:ext cx="1191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Line 65"/>
              <p:cNvSpPr/>
              <p:nvPr/>
            </p:nvSpPr>
            <p:spPr>
              <a:xfrm>
                <a:off x="6919200" y="1385640"/>
                <a:ext cx="11916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7" name="Text Box 66"/>
            <p:cNvSpPr/>
            <p:nvPr/>
          </p:nvSpPr>
          <p:spPr>
            <a:xfrm flipV="1">
              <a:off x="6658560" y="719280"/>
              <a:ext cx="362880" cy="83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rotein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Text Box 67"/>
            <p:cNvSpPr/>
            <p:nvPr/>
          </p:nvSpPr>
          <p:spPr>
            <a:xfrm flipV="1">
              <a:off x="6995520" y="710280"/>
              <a:ext cx="362880" cy="83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rotein 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9" name="Group 68"/>
            <p:cNvGrpSpPr/>
            <p:nvPr/>
          </p:nvGrpSpPr>
          <p:grpSpPr>
            <a:xfrm>
              <a:off x="7298280" y="743760"/>
              <a:ext cx="603360" cy="1735560"/>
              <a:chOff x="7298280" y="743760"/>
              <a:chExt cx="603360" cy="1735560"/>
            </a:xfrm>
          </p:grpSpPr>
          <p:sp>
            <p:nvSpPr>
              <p:cNvPr id="260" name="AutoShape 69"/>
              <p:cNvSpPr/>
              <p:nvPr/>
            </p:nvSpPr>
            <p:spPr>
              <a:xfrm>
                <a:off x="7298280" y="743760"/>
                <a:ext cx="603360" cy="612360"/>
              </a:xfrm>
              <a:prstGeom prst="can">
                <a:avLst>
                  <a:gd name="adj" fmla="val 27689"/>
                </a:avLst>
              </a:prstGeom>
              <a:solidFill>
                <a:srgbClr val="ff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70"/>
              <p:cNvSpPr/>
              <p:nvPr/>
            </p:nvSpPr>
            <p:spPr>
              <a:xfrm>
                <a:off x="7594920" y="1348920"/>
                <a:ext cx="0" cy="214920"/>
              </a:xfrm>
              <a:prstGeom prst="line">
                <a:avLst/>
              </a:prstGeom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Rectangle 71"/>
              <p:cNvSpPr/>
              <p:nvPr/>
            </p:nvSpPr>
            <p:spPr>
              <a:xfrm>
                <a:off x="7493040" y="1575000"/>
                <a:ext cx="211680" cy="904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Text Box 72"/>
              <p:cNvSpPr/>
              <p:nvPr/>
            </p:nvSpPr>
            <p:spPr>
              <a:xfrm flipV="1">
                <a:off x="7451280" y="1456560"/>
                <a:ext cx="362880" cy="918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RF19IV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4" name="Text Box 73"/>
            <p:cNvSpPr/>
            <p:nvPr/>
          </p:nvSpPr>
          <p:spPr>
            <a:xfrm>
              <a:off x="7222680" y="918720"/>
              <a:ext cx="817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mCherr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Qinghua Pan</cp:lastModifiedBy>
  <cp:lastPrinted>2013-08-28T03:47:06Z</cp:lastPrinted>
  <dcterms:modified xsi:type="dcterms:W3CDTF">2014-05-03T02:55:26Z</dcterms:modified>
  <cp:revision>3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